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23"/>
  </p:notesMasterIdLst>
  <p:sldIdLst>
    <p:sldId id="267" r:id="rId2"/>
    <p:sldId id="274" r:id="rId3"/>
    <p:sldId id="275" r:id="rId4"/>
    <p:sldId id="276" r:id="rId5"/>
    <p:sldId id="277" r:id="rId6"/>
    <p:sldId id="303" r:id="rId7"/>
    <p:sldId id="286" r:id="rId8"/>
    <p:sldId id="288" r:id="rId9"/>
    <p:sldId id="289" r:id="rId10"/>
    <p:sldId id="290" r:id="rId11"/>
    <p:sldId id="291" r:id="rId12"/>
    <p:sldId id="292" r:id="rId13"/>
    <p:sldId id="293" r:id="rId14"/>
    <p:sldId id="294" r:id="rId15"/>
    <p:sldId id="295" r:id="rId16"/>
    <p:sldId id="296" r:id="rId17"/>
    <p:sldId id="297" r:id="rId18"/>
    <p:sldId id="301" r:id="rId19"/>
    <p:sldId id="302" r:id="rId20"/>
    <p:sldId id="298" r:id="rId21"/>
    <p:sldId id="299" r:id="rId2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40"/>
  </p:normalViewPr>
  <p:slideViewPr>
    <p:cSldViewPr snapToGrid="0" snapToObjects="1" showGuides="1">
      <p:cViewPr varScale="1">
        <p:scale>
          <a:sx n="160" d="100"/>
          <a:sy n="160" d="100"/>
        </p:scale>
        <p:origin x="199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F44AF2-BCE1-1C4F-82E2-018038111C8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7D5282-BB01-8F43-8419-B623D461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9226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1863" y="698500"/>
            <a:ext cx="2619375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9ED655-D582-4253-8C99-E533BFBFE4B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5914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1863" y="698500"/>
            <a:ext cx="2619375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MY2</a:t>
            </a:r>
            <a:r>
              <a:rPr lang="en-US" baseline="0" dirty="0"/>
              <a:t> locatio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605C13-9E32-48AC-92F1-A85EA9E5B15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4976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1863" y="698500"/>
            <a:ext cx="2619375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TX-M</a:t>
            </a:r>
            <a:r>
              <a:rPr lang="en-US" baseline="0" dirty="0"/>
              <a:t> locatio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605C13-9E32-48AC-92F1-A85EA9E5B15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8051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1863" y="698500"/>
            <a:ext cx="2619375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TX-M-27 loc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605C13-9E32-48AC-92F1-A85EA9E5B15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60187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1863" y="698500"/>
            <a:ext cx="2619375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. CTX-M-32 chromosome</a:t>
            </a:r>
          </a:p>
          <a:p>
            <a:r>
              <a:rPr lang="en-US" dirty="0"/>
              <a:t>E. CTX-M-15, CTX-M-5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605C13-9E32-48AC-92F1-A85EA9E5B15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827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31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594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814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921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010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039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78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855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374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63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993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423DE-6233-5C45-960C-2A94990DD29A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951AE-D31B-094A-813B-98FAAB790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54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59984" y="0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1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729" y="539552"/>
            <a:ext cx="4860541" cy="1491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0540" y="2159732"/>
            <a:ext cx="4836919" cy="299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729" y="2612818"/>
            <a:ext cx="4860541" cy="10950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730" y="3828123"/>
            <a:ext cx="4860540" cy="288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229" y="4249066"/>
            <a:ext cx="4850039" cy="299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5231" y="4703871"/>
            <a:ext cx="4867538" cy="8361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5232" y="5684072"/>
            <a:ext cx="4867535" cy="8230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6635767"/>
            <a:ext cx="4860541" cy="1356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8079485"/>
            <a:ext cx="4860542" cy="2851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8472639"/>
            <a:ext cx="4860540" cy="4198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8" name="TextBox 117"/>
          <p:cNvSpPr txBox="1"/>
          <p:nvPr/>
        </p:nvSpPr>
        <p:spPr>
          <a:xfrm>
            <a:off x="774322" y="48380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774322" y="210398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774322" y="255577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774322" y="376016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764796" y="419221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64796" y="464400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764704" y="5632375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764796" y="65882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800708" y="8028384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764796" y="844068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1376772" y="1918737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10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1376172" y="2339752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20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1376772" y="3580147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744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1376772" y="3995936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906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1376772" y="4427984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1121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1376772" y="541635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1172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1384798" y="6388459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4086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1384798" y="786462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5727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1384798" y="825544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6416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376772" y="879550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T6465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805264" y="47857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805264" y="1702713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805264" y="129563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805264" y="212372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805264" y="226774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805264" y="256680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805264" y="269979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805264" y="309583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805264" y="3502913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5805264" y="379094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813314" y="392392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813314" y="418698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813314" y="433938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813314" y="4655041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813314" y="4807441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813314" y="4959841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813314" y="511206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813314" y="562714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5813314" y="631122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813314" y="687625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813314" y="658822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813314" y="727230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813314" y="778738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5813314" y="803941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813314" y="817240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813314" y="857947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813314" y="868748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722740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D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744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5122" name="Picture 2" descr="R:\Jeong_lab\Hemmos Lab member folders\Hemmos-Shinyoung\AMR_ESBL_commercial\Parsnp_coregenome\phylogeny of esbls in commercial farm\ST744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680" b="24590"/>
          <a:stretch/>
        </p:blipFill>
        <p:spPr bwMode="auto">
          <a:xfrm>
            <a:off x="2032292" y="1187624"/>
            <a:ext cx="2741569" cy="73448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104964" y="2843808"/>
            <a:ext cx="396044" cy="39604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4873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E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906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146" name="Picture 2" descr="R:\Jeong_lab\Hemmos Lab member folders\Hemmos-Shinyoung\AMR_ESBL_commercial\Parsnp_coregenome\phylogeny of esbls in commercial farm\ST906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27" b="24838"/>
          <a:stretch/>
        </p:blipFill>
        <p:spPr bwMode="auto">
          <a:xfrm>
            <a:off x="1520788" y="1511660"/>
            <a:ext cx="3925791" cy="46270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096852" y="3347864"/>
            <a:ext cx="576064" cy="28803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218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F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1121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7170" name="Picture 2" descr="R:\Jeong_lab\Hemmos Lab member folders\Hemmos-Shinyoung\AMR_ESBL_commercial\Parsnp_coregenome\phylogeny of esbls in commercial farm\ST112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7219" y="2123728"/>
            <a:ext cx="2619376" cy="3094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32956" y="2771800"/>
            <a:ext cx="684076" cy="39604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3548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G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1172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8194" name="Picture 2" descr="R:\Jeong_lab\Hemmos Lab member folders\Hemmos-Shinyoung\AMR_ESBL_commercial\Parsnp_coregenome\phylogeny of esbls in commercial farm\ST1172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6832" y="2375756"/>
            <a:ext cx="2922587" cy="233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924944" y="2771800"/>
            <a:ext cx="900100" cy="104411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89197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H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1266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4338" name="Picture 2" descr="R:\Jeong_lab\Hemmos Lab member folders\Hemmos-Shinyoung\AMR_ESBL_commercial\Parsnp_coregenome\phylogeny of esbls in commercial farm\ST1266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0463" y="2617768"/>
            <a:ext cx="4484687" cy="4140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1844824" y="2627784"/>
            <a:ext cx="864096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89604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I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1674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3314" name="Picture 2" descr="R:\Jeong_lab\Hemmos Lab member folders\Hemmos-Shinyoung\AMR_ESBL_commercial\Parsnp_coregenome\phylogeny of esbls in commercial farm\ST1674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6732" y="2411760"/>
            <a:ext cx="4846638" cy="3683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348880" y="3635896"/>
            <a:ext cx="720080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86943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J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2509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2290" name="Picture 2" descr="R:\Jeong_lab\Hemmos Lab member folders\Hemmos-Shinyoung\AMR_ESBL_commercial\Parsnp_coregenome\phylogeny of esbls in commercial farm\ST2509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6872" y="2591780"/>
            <a:ext cx="2227263" cy="18938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104964" y="3527884"/>
            <a:ext cx="720080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98215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K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4086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1266" name="Picture 2" descr="R:\Jeong_lab\Hemmos Lab member folders\Hemmos-Shinyoung\AMR_ESBL_commercial\Parsnp_coregenome\phylogeny of esbls in commercial farm\ST4086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0768" y="2447764"/>
            <a:ext cx="4187825" cy="2465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348880" y="3167844"/>
            <a:ext cx="720080" cy="79208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312876" y="2699792"/>
            <a:ext cx="720080" cy="32403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89895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5727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051" name="Picture 3" descr="R:\Jeong_lab\Hemmos Lab member folders\Hemmos-Shinyoung\AMR_ESBL_commercial\Parsnp_coregenome\phylogeny of esbls in commercial farm\ST5727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2540979"/>
            <a:ext cx="5102225" cy="4162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L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068960" y="2735796"/>
            <a:ext cx="792088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104964" y="3095836"/>
            <a:ext cx="792088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248980" y="3455876"/>
            <a:ext cx="792088" cy="32403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2672916" y="4319972"/>
            <a:ext cx="792088" cy="86409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2924944" y="3959932"/>
            <a:ext cx="792088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10043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6353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026" name="Picture 2" descr="R:\Jeong_lab\Hemmos Lab member folders\Hemmos-Shinyoung\AMR_ESBL_commercial\Parsnp_coregenome\phylogeny of esbls in commercial farm\ST6353-phylogeny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4864" y="2807804"/>
            <a:ext cx="2732088" cy="2008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M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032956" y="3095836"/>
            <a:ext cx="792088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16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6572" y="592666"/>
            <a:ext cx="4758267" cy="8398935"/>
          </a:xfrm>
        </p:spPr>
      </p:pic>
      <p:sp>
        <p:nvSpPr>
          <p:cNvPr id="3" name="TextBox 2"/>
          <p:cNvSpPr txBox="1"/>
          <p:nvPr/>
        </p:nvSpPr>
        <p:spPr>
          <a:xfrm>
            <a:off x="719679" y="496895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9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22593" y="899231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2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19679" y="1315624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2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19678" y="1740479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28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2593" y="2139172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29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22593" y="2581727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3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22593" y="299923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91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19678" y="3429378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727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19676" y="382531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74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22593" y="426422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93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19675" y="4666559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06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2593" y="510547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08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19674" y="550780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48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22593" y="593391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6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31141" y="6349055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6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24432" y="678796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93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19672" y="719030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94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19671" y="7629215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44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24432" y="803155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46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24432" y="847046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58</a:t>
            </a:r>
          </a:p>
        </p:txBody>
      </p:sp>
      <p:sp>
        <p:nvSpPr>
          <p:cNvPr id="24" name="TextBox 23"/>
          <p:cNvSpPr txBox="1"/>
          <p:nvPr/>
        </p:nvSpPr>
        <p:spPr>
          <a:xfrm rot="19502716">
            <a:off x="3142172" y="391720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B11</a:t>
            </a:r>
          </a:p>
        </p:txBody>
      </p:sp>
      <p:sp>
        <p:nvSpPr>
          <p:cNvPr id="25" name="TextBox 24"/>
          <p:cNvSpPr txBox="1"/>
          <p:nvPr/>
        </p:nvSpPr>
        <p:spPr>
          <a:xfrm rot="19502716">
            <a:off x="3585466" y="414867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B4</a:t>
            </a:r>
          </a:p>
        </p:txBody>
      </p:sp>
      <p:sp>
        <p:nvSpPr>
          <p:cNvPr id="26" name="TextBox 25"/>
          <p:cNvSpPr txBox="1"/>
          <p:nvPr/>
        </p:nvSpPr>
        <p:spPr>
          <a:xfrm rot="19502716">
            <a:off x="3441450" y="414867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B5</a:t>
            </a:r>
          </a:p>
        </p:txBody>
      </p:sp>
      <p:sp>
        <p:nvSpPr>
          <p:cNvPr id="27" name="TextBox 26"/>
          <p:cNvSpPr txBox="1"/>
          <p:nvPr/>
        </p:nvSpPr>
        <p:spPr>
          <a:xfrm rot="19502716">
            <a:off x="3928818" y="287017"/>
            <a:ext cx="79220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cB</a:t>
            </a:r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antitoxin)</a:t>
            </a:r>
          </a:p>
        </p:txBody>
      </p:sp>
      <p:sp>
        <p:nvSpPr>
          <p:cNvPr id="28" name="TextBox 27"/>
          <p:cNvSpPr txBox="1"/>
          <p:nvPr/>
        </p:nvSpPr>
        <p:spPr>
          <a:xfrm rot="19502716">
            <a:off x="4655731" y="840026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9502716">
            <a:off x="4799747" y="1263159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9502716">
            <a:off x="2525828" y="1227341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</a:t>
            </a:r>
          </a:p>
        </p:txBody>
      </p:sp>
      <p:sp>
        <p:nvSpPr>
          <p:cNvPr id="31" name="TextBox 30"/>
          <p:cNvSpPr txBox="1"/>
          <p:nvPr/>
        </p:nvSpPr>
        <p:spPr>
          <a:xfrm rot="19502716">
            <a:off x="2666377" y="1268577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33" name="TextBox 32"/>
          <p:cNvSpPr txBox="1"/>
          <p:nvPr/>
        </p:nvSpPr>
        <p:spPr>
          <a:xfrm rot="19502716">
            <a:off x="4799747" y="1659203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9502716">
            <a:off x="2536230" y="1623385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</a:t>
            </a:r>
          </a:p>
        </p:txBody>
      </p:sp>
      <p:sp>
        <p:nvSpPr>
          <p:cNvPr id="35" name="TextBox 34"/>
          <p:cNvSpPr txBox="1"/>
          <p:nvPr/>
        </p:nvSpPr>
        <p:spPr>
          <a:xfrm rot="19502716">
            <a:off x="2656852" y="1672763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36" name="TextBox 35"/>
          <p:cNvSpPr txBox="1"/>
          <p:nvPr/>
        </p:nvSpPr>
        <p:spPr>
          <a:xfrm rot="19502716">
            <a:off x="4619727" y="2086570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9502716">
            <a:off x="4819446" y="2523299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9502716">
            <a:off x="2514893" y="2460388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9502716">
            <a:off x="2651661" y="2528809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43" name="TextBox 42"/>
          <p:cNvSpPr txBox="1"/>
          <p:nvPr/>
        </p:nvSpPr>
        <p:spPr>
          <a:xfrm rot="19502716">
            <a:off x="5062620" y="2916393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9502716">
            <a:off x="2802925" y="2856432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9502716">
            <a:off x="2939693" y="2932437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46" name="TextBox 45"/>
          <p:cNvSpPr txBox="1"/>
          <p:nvPr/>
        </p:nvSpPr>
        <p:spPr>
          <a:xfrm rot="19502716">
            <a:off x="2482623" y="2916595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A)</a:t>
            </a:r>
          </a:p>
        </p:txBody>
      </p:sp>
      <p:sp>
        <p:nvSpPr>
          <p:cNvPr id="47" name="TextBox 46"/>
          <p:cNvSpPr txBox="1"/>
          <p:nvPr/>
        </p:nvSpPr>
        <p:spPr>
          <a:xfrm rot="19502716">
            <a:off x="2604776" y="2906030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R)</a:t>
            </a:r>
          </a:p>
        </p:txBody>
      </p:sp>
      <p:sp>
        <p:nvSpPr>
          <p:cNvPr id="48" name="TextBox 47"/>
          <p:cNvSpPr txBox="1"/>
          <p:nvPr/>
        </p:nvSpPr>
        <p:spPr>
          <a:xfrm rot="19502716">
            <a:off x="4007659" y="3352320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9502716">
            <a:off x="4579842" y="3754276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9502716">
            <a:off x="2695755" y="2870300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6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9502716">
            <a:off x="2298869" y="3720528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9502716">
            <a:off x="2435637" y="3788949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53" name="TextBox 52"/>
          <p:cNvSpPr txBox="1"/>
          <p:nvPr/>
        </p:nvSpPr>
        <p:spPr>
          <a:xfrm rot="19502716">
            <a:off x="1960423" y="3768744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A)</a:t>
            </a:r>
          </a:p>
        </p:txBody>
      </p:sp>
      <p:sp>
        <p:nvSpPr>
          <p:cNvPr id="54" name="TextBox 53"/>
          <p:cNvSpPr txBox="1"/>
          <p:nvPr/>
        </p:nvSpPr>
        <p:spPr>
          <a:xfrm rot="19502716">
            <a:off x="2064716" y="3779365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R)</a:t>
            </a:r>
          </a:p>
        </p:txBody>
      </p:sp>
      <p:sp>
        <p:nvSpPr>
          <p:cNvPr id="55" name="TextBox 54"/>
          <p:cNvSpPr txBox="1"/>
          <p:nvPr/>
        </p:nvSpPr>
        <p:spPr>
          <a:xfrm rot="19502716">
            <a:off x="2191699" y="3729715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6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9502716">
            <a:off x="1848614" y="3771958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(R)</a:t>
            </a:r>
          </a:p>
        </p:txBody>
      </p:sp>
      <p:sp>
        <p:nvSpPr>
          <p:cNvPr id="57" name="TextBox 56"/>
          <p:cNvSpPr txBox="1"/>
          <p:nvPr/>
        </p:nvSpPr>
        <p:spPr>
          <a:xfrm rot="19502716">
            <a:off x="4835751" y="4179483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9502716">
            <a:off x="2550897" y="4126064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9502716">
            <a:off x="2687665" y="4182888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60" name="TextBox 59"/>
          <p:cNvSpPr txBox="1"/>
          <p:nvPr/>
        </p:nvSpPr>
        <p:spPr>
          <a:xfrm rot="19502716">
            <a:off x="2212451" y="4167089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A)</a:t>
            </a:r>
          </a:p>
        </p:txBody>
      </p:sp>
      <p:sp>
        <p:nvSpPr>
          <p:cNvPr id="61" name="TextBox 60"/>
          <p:cNvSpPr txBox="1"/>
          <p:nvPr/>
        </p:nvSpPr>
        <p:spPr>
          <a:xfrm rot="19502716">
            <a:off x="2301512" y="4174087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R)</a:t>
            </a:r>
          </a:p>
        </p:txBody>
      </p:sp>
      <p:sp>
        <p:nvSpPr>
          <p:cNvPr id="62" name="TextBox 61"/>
          <p:cNvSpPr txBox="1"/>
          <p:nvPr/>
        </p:nvSpPr>
        <p:spPr>
          <a:xfrm rot="19502716">
            <a:off x="2443727" y="4129429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6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9502716">
            <a:off x="2091978" y="4168002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(R)</a:t>
            </a:r>
          </a:p>
        </p:txBody>
      </p:sp>
      <p:sp>
        <p:nvSpPr>
          <p:cNvPr id="65" name="TextBox 64"/>
          <p:cNvSpPr txBox="1"/>
          <p:nvPr/>
        </p:nvSpPr>
        <p:spPr>
          <a:xfrm rot="19502716">
            <a:off x="4259687" y="4611531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 rot="19502716">
            <a:off x="4835751" y="5007575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9502716">
            <a:off x="2719121" y="4944664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9502716">
            <a:off x="2871631" y="5010980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69" name="TextBox 68"/>
          <p:cNvSpPr txBox="1"/>
          <p:nvPr/>
        </p:nvSpPr>
        <p:spPr>
          <a:xfrm rot="19502716">
            <a:off x="2356467" y="5005271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A)</a:t>
            </a:r>
          </a:p>
        </p:txBody>
      </p:sp>
      <p:sp>
        <p:nvSpPr>
          <p:cNvPr id="70" name="TextBox 69"/>
          <p:cNvSpPr txBox="1"/>
          <p:nvPr/>
        </p:nvSpPr>
        <p:spPr>
          <a:xfrm rot="19502716">
            <a:off x="2481532" y="499426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R)</a:t>
            </a:r>
          </a:p>
        </p:txBody>
      </p:sp>
      <p:sp>
        <p:nvSpPr>
          <p:cNvPr id="71" name="TextBox 70"/>
          <p:cNvSpPr txBox="1"/>
          <p:nvPr/>
        </p:nvSpPr>
        <p:spPr>
          <a:xfrm rot="19502716">
            <a:off x="2587743" y="4958532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6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9502716">
            <a:off x="2208654" y="499940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(R)</a:t>
            </a:r>
          </a:p>
        </p:txBody>
      </p:sp>
      <p:sp>
        <p:nvSpPr>
          <p:cNvPr id="73" name="TextBox 72"/>
          <p:cNvSpPr txBox="1"/>
          <p:nvPr/>
        </p:nvSpPr>
        <p:spPr>
          <a:xfrm rot="19502716">
            <a:off x="2694913" y="6204804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3’’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9502716">
            <a:off x="2832659" y="6271120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2</a:t>
            </a:r>
          </a:p>
        </p:txBody>
      </p:sp>
      <p:sp>
        <p:nvSpPr>
          <p:cNvPr id="75" name="TextBox 74"/>
          <p:cNvSpPr txBox="1"/>
          <p:nvPr/>
        </p:nvSpPr>
        <p:spPr>
          <a:xfrm rot="19502716">
            <a:off x="2360423" y="6256157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A)</a:t>
            </a:r>
          </a:p>
        </p:txBody>
      </p:sp>
      <p:sp>
        <p:nvSpPr>
          <p:cNvPr id="76" name="TextBox 75"/>
          <p:cNvSpPr txBox="1"/>
          <p:nvPr/>
        </p:nvSpPr>
        <p:spPr>
          <a:xfrm rot="19502716">
            <a:off x="2457470" y="6274943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(R)</a:t>
            </a:r>
          </a:p>
        </p:txBody>
      </p:sp>
      <p:sp>
        <p:nvSpPr>
          <p:cNvPr id="77" name="TextBox 76"/>
          <p:cNvSpPr txBox="1"/>
          <p:nvPr/>
        </p:nvSpPr>
        <p:spPr>
          <a:xfrm rot="19502716">
            <a:off x="2587743" y="6218672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H(6)-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 rot="19502716">
            <a:off x="2224663" y="6250296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(R)</a:t>
            </a:r>
          </a:p>
        </p:txBody>
      </p:sp>
      <p:sp>
        <p:nvSpPr>
          <p:cNvPr id="79" name="TextBox 78"/>
          <p:cNvSpPr txBox="1"/>
          <p:nvPr/>
        </p:nvSpPr>
        <p:spPr>
          <a:xfrm rot="19502716">
            <a:off x="4356819" y="5449578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9502716">
            <a:off x="4347292" y="5841282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 rot="19502716">
            <a:off x="4835751" y="6263061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9502716">
            <a:off x="2591683" y="6699763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gE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9502716">
            <a:off x="3201060" y="6654393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icin</a:t>
            </a:r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A</a:t>
            </a:r>
          </a:p>
        </p:txBody>
      </p:sp>
      <p:sp>
        <p:nvSpPr>
          <p:cNvPr id="85" name="TextBox 84"/>
          <p:cNvSpPr txBox="1"/>
          <p:nvPr/>
        </p:nvSpPr>
        <p:spPr>
          <a:xfrm rot="19502716">
            <a:off x="4579766" y="378858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86" name="TextBox 85"/>
          <p:cNvSpPr txBox="1"/>
          <p:nvPr/>
        </p:nvSpPr>
        <p:spPr>
          <a:xfrm rot="19502716">
            <a:off x="4363742" y="824227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87" name="TextBox 86"/>
          <p:cNvSpPr txBox="1"/>
          <p:nvPr/>
        </p:nvSpPr>
        <p:spPr>
          <a:xfrm rot="19502716">
            <a:off x="4546140" y="1242954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88" name="TextBox 87"/>
          <p:cNvSpPr txBox="1"/>
          <p:nvPr/>
        </p:nvSpPr>
        <p:spPr>
          <a:xfrm rot="19502716">
            <a:off x="5215921" y="84947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6</a:t>
            </a:r>
          </a:p>
        </p:txBody>
      </p:sp>
      <p:sp>
        <p:nvSpPr>
          <p:cNvPr id="89" name="TextBox 88"/>
          <p:cNvSpPr txBox="1"/>
          <p:nvPr/>
        </p:nvSpPr>
        <p:spPr>
          <a:xfrm rot="19502716">
            <a:off x="4399746" y="2071046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90" name="TextBox 89"/>
          <p:cNvSpPr txBox="1"/>
          <p:nvPr/>
        </p:nvSpPr>
        <p:spPr>
          <a:xfrm rot="19502716">
            <a:off x="5211193" y="210961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6</a:t>
            </a:r>
          </a:p>
        </p:txBody>
      </p:sp>
      <p:sp>
        <p:nvSpPr>
          <p:cNvPr id="91" name="TextBox 90"/>
          <p:cNvSpPr txBox="1"/>
          <p:nvPr/>
        </p:nvSpPr>
        <p:spPr>
          <a:xfrm rot="19502716">
            <a:off x="4543762" y="1643489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92" name="TextBox 91"/>
          <p:cNvSpPr txBox="1"/>
          <p:nvPr/>
        </p:nvSpPr>
        <p:spPr>
          <a:xfrm rot="19502716">
            <a:off x="4543762" y="2503094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93" name="TextBox 92"/>
          <p:cNvSpPr txBox="1"/>
          <p:nvPr/>
        </p:nvSpPr>
        <p:spPr>
          <a:xfrm rot="19502716">
            <a:off x="4858348" y="2891637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94" name="TextBox 93"/>
          <p:cNvSpPr txBox="1"/>
          <p:nvPr/>
        </p:nvSpPr>
        <p:spPr>
          <a:xfrm rot="19359977">
            <a:off x="2395636" y="2921627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91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2530360" y="3123456"/>
            <a:ext cx="7024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osase</a:t>
            </a:r>
          </a:p>
        </p:txBody>
      </p:sp>
      <p:sp>
        <p:nvSpPr>
          <p:cNvPr id="105" name="TextBox 104"/>
          <p:cNvSpPr txBox="1"/>
          <p:nvPr/>
        </p:nvSpPr>
        <p:spPr>
          <a:xfrm rot="19502716">
            <a:off x="3751674" y="3331186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06" name="TextBox 105"/>
          <p:cNvSpPr txBox="1"/>
          <p:nvPr/>
        </p:nvSpPr>
        <p:spPr>
          <a:xfrm rot="19502716">
            <a:off x="4291734" y="3740551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07" name="TextBox 106"/>
          <p:cNvSpPr txBox="1"/>
          <p:nvPr/>
        </p:nvSpPr>
        <p:spPr>
          <a:xfrm rot="19468126">
            <a:off x="1712191" y="3788139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91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1988840" y="3975901"/>
            <a:ext cx="7024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osase</a:t>
            </a:r>
          </a:p>
        </p:txBody>
      </p:sp>
      <p:sp>
        <p:nvSpPr>
          <p:cNvPr id="111" name="TextBox 110"/>
          <p:cNvSpPr txBox="1"/>
          <p:nvPr/>
        </p:nvSpPr>
        <p:spPr>
          <a:xfrm rot="19502716">
            <a:off x="4579766" y="4159278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12" name="TextBox 111"/>
          <p:cNvSpPr txBox="1"/>
          <p:nvPr/>
        </p:nvSpPr>
        <p:spPr>
          <a:xfrm rot="19502716">
            <a:off x="4039706" y="4591326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13" name="TextBox 112"/>
          <p:cNvSpPr txBox="1"/>
          <p:nvPr/>
        </p:nvSpPr>
        <p:spPr>
          <a:xfrm rot="19502716">
            <a:off x="4579766" y="4987370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14" name="TextBox 113"/>
          <p:cNvSpPr txBox="1"/>
          <p:nvPr/>
        </p:nvSpPr>
        <p:spPr>
          <a:xfrm rot="19502716">
            <a:off x="4095852" y="5432739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15" name="TextBox 114"/>
          <p:cNvSpPr txBox="1"/>
          <p:nvPr/>
        </p:nvSpPr>
        <p:spPr>
          <a:xfrm rot="19468126">
            <a:off x="1964219" y="4184183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91</a:t>
            </a:r>
          </a:p>
        </p:txBody>
      </p:sp>
      <p:sp>
        <p:nvSpPr>
          <p:cNvPr id="116" name="TextBox 115"/>
          <p:cNvSpPr txBox="1"/>
          <p:nvPr/>
        </p:nvSpPr>
        <p:spPr>
          <a:xfrm rot="19468126">
            <a:off x="2112501" y="5011790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91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2207597" y="4404207"/>
            <a:ext cx="7024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osase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2369188" y="5211688"/>
            <a:ext cx="7024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osase</a:t>
            </a:r>
          </a:p>
        </p:txBody>
      </p:sp>
      <p:sp>
        <p:nvSpPr>
          <p:cNvPr id="119" name="TextBox 118"/>
          <p:cNvSpPr txBox="1"/>
          <p:nvPr/>
        </p:nvSpPr>
        <p:spPr>
          <a:xfrm rot="19502716">
            <a:off x="4096672" y="5827442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20" name="TextBox 119"/>
          <p:cNvSpPr txBox="1"/>
          <p:nvPr/>
        </p:nvSpPr>
        <p:spPr>
          <a:xfrm rot="19502716">
            <a:off x="4579766" y="6247510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2369188" y="6508703"/>
            <a:ext cx="7024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osase</a:t>
            </a:r>
          </a:p>
        </p:txBody>
      </p:sp>
      <p:sp>
        <p:nvSpPr>
          <p:cNvPr id="122" name="TextBox 121"/>
          <p:cNvSpPr txBox="1"/>
          <p:nvPr/>
        </p:nvSpPr>
        <p:spPr>
          <a:xfrm rot="19468126">
            <a:off x="2098071" y="6266833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91</a:t>
            </a:r>
          </a:p>
        </p:txBody>
      </p:sp>
      <p:sp>
        <p:nvSpPr>
          <p:cNvPr id="123" name="TextBox 122"/>
          <p:cNvSpPr txBox="1"/>
          <p:nvPr/>
        </p:nvSpPr>
        <p:spPr>
          <a:xfrm rot="19468126">
            <a:off x="1908696" y="628092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6</a:t>
            </a:r>
          </a:p>
        </p:txBody>
      </p:sp>
      <p:sp>
        <p:nvSpPr>
          <p:cNvPr id="124" name="TextBox 123"/>
          <p:cNvSpPr txBox="1"/>
          <p:nvPr/>
        </p:nvSpPr>
        <p:spPr>
          <a:xfrm rot="19468126">
            <a:off x="5967246" y="629796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6</a:t>
            </a:r>
          </a:p>
        </p:txBody>
      </p:sp>
      <p:sp>
        <p:nvSpPr>
          <p:cNvPr id="125" name="TextBox 124"/>
          <p:cNvSpPr txBox="1"/>
          <p:nvPr/>
        </p:nvSpPr>
        <p:spPr>
          <a:xfrm rot="19468126">
            <a:off x="2868585" y="6700333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66</a:t>
            </a:r>
          </a:p>
        </p:txBody>
      </p:sp>
      <p:sp>
        <p:nvSpPr>
          <p:cNvPr id="126" name="TextBox 125"/>
          <p:cNvSpPr txBox="1"/>
          <p:nvPr/>
        </p:nvSpPr>
        <p:spPr>
          <a:xfrm rot="19468126">
            <a:off x="3847400" y="713094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</a:t>
            </a:r>
          </a:p>
        </p:txBody>
      </p:sp>
      <p:sp>
        <p:nvSpPr>
          <p:cNvPr id="127" name="TextBox 126"/>
          <p:cNvSpPr txBox="1"/>
          <p:nvPr/>
        </p:nvSpPr>
        <p:spPr>
          <a:xfrm rot="19468126">
            <a:off x="3889184" y="756318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 rot="19468126">
            <a:off x="3894881" y="798035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7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78604" y="-57595"/>
            <a:ext cx="2594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2A.</a:t>
            </a:r>
            <a:endParaRPr lang="ko-KR" altLang="en-US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987445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6416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0242" name="Picture 2" descr="R:\Jeong_lab\Hemmos Lab member folders\Hemmos-Shinyoung\AMR_ESBL_commercial\Parsnp_coregenome\phylogeny of esbls in commercial farm\ST6416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0232" y="3059832"/>
            <a:ext cx="2760662" cy="1436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492896" y="3167844"/>
            <a:ext cx="792088" cy="28803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N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10386991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6466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9218" name="Picture 2" descr="R:\Jeong_lab\Hemmos Lab member folders\Hemmos-Shinyoung\AMR_ESBL_commercial\Parsnp_coregenome\phylogeny of esbls in commercial farm\ST6466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4824" y="2915816"/>
            <a:ext cx="3130550" cy="1514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492896" y="3347864"/>
            <a:ext cx="864096" cy="39604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O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405995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68695" y="788524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729</a:t>
            </a:r>
          </a:p>
        </p:txBody>
      </p:sp>
      <p:pic>
        <p:nvPicPr>
          <p:cNvPr id="1026" name="Picture 2" descr="C:\Users\shinyoung\Downloads\ctx-m-1-v1.bmp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9985" y="440448"/>
            <a:ext cx="3699255" cy="79354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868694" y="755606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726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68690" y="719030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405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68695" y="682454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92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68695" y="645878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91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68695" y="609302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909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68694" y="572726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89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68690" y="536150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889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68695" y="501091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886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68695" y="4681728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3864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68695" y="4300799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272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68694" y="391363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272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68690" y="3572918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68695" y="3203519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68695" y="2852928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68685" y="2471999"/>
            <a:ext cx="9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68680" y="2142815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07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68680" y="1777055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06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68685" y="1411295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0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68685" y="1045535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01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68680" y="679775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68680" y="329184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67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658717" y="252605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660370" y="58401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658716" y="94405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660370" y="1304095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660370" y="166413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660370" y="202417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660370" y="238421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658715" y="274425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658714" y="310429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659117" y="346433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658713" y="490449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659116" y="5298652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650646" y="562457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660370" y="5984616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658713" y="7098852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659116" y="7458892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650646" y="7818932"/>
            <a:ext cx="6270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h(A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78604" y="-57595"/>
            <a:ext cx="2594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2B.</a:t>
            </a:r>
            <a:endParaRPr lang="ko-KR" altLang="en-US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624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91"/>
          <a:stretch/>
        </p:blipFill>
        <p:spPr bwMode="auto">
          <a:xfrm>
            <a:off x="1750479" y="1846535"/>
            <a:ext cx="3442717" cy="49937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794789" y="249460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37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794789" y="208834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27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794789" y="2942914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39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794789" y="375474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48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94789" y="3338958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44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94789" y="4186795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58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794789" y="5031146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66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794789" y="4599098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62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94789" y="5446935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76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94789" y="587898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81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94789" y="631103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20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8604" y="-57595"/>
            <a:ext cx="2594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2C.</a:t>
            </a:r>
            <a:endParaRPr lang="ko-KR" altLang="en-US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23315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341" y="1511660"/>
            <a:ext cx="4428963" cy="25332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TextBox 40"/>
          <p:cNvSpPr txBox="1"/>
          <p:nvPr/>
        </p:nvSpPr>
        <p:spPr>
          <a:xfrm>
            <a:off x="692696" y="341987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5395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92696" y="286006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5142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92696" y="2284003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5139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00585" y="1763688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JK414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8604" y="-57595"/>
            <a:ext cx="2594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2D.</a:t>
            </a:r>
            <a:endParaRPr lang="ko-KR" altLang="en-US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54010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056" y="3059910"/>
            <a:ext cx="4283076" cy="39158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056" y="3600450"/>
            <a:ext cx="4283075" cy="39158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19679" y="293233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5143</a:t>
            </a:r>
          </a:p>
          <a:p>
            <a:pPr latinLnBrk="0"/>
            <a:endParaRPr 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19679" y="3475968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JK493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363724" y="2897574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nrS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763324" y="2897418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411396" y="2897418"/>
            <a:ext cx="80663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X-M-1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383504" y="2897418"/>
            <a:ext cx="11897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3 transposas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830722" y="2897417"/>
            <a:ext cx="3866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355612" y="3438559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138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39488" y="3438559"/>
            <a:ext cx="80663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X-M-55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8604" y="-57595"/>
            <a:ext cx="2594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2E.</a:t>
            </a:r>
            <a:endParaRPr lang="ko-KR" altLang="en-US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75947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A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026" name="Picture 2" descr="R:\Jeong_lab\Hemmos Lab member folders\Hemmos-Shinyoung\AMR_ESBL_commercial\Parsnp_coregenome\phylogeny of esbls in commercial farm\ST10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4683"/>
          <a:stretch/>
        </p:blipFill>
        <p:spPr bwMode="auto">
          <a:xfrm>
            <a:off x="1736812" y="1187624"/>
            <a:ext cx="3393341" cy="69847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10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240868" y="1367644"/>
            <a:ext cx="396044" cy="61206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0513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R:\Jeong_lab\Hemmos Lab member folders\Hemmos-Shinyoung\AMR_ESBL_commercial\Parsnp_coregenome\phylogeny of esbls in commercial farm\ST101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608" b="24950"/>
          <a:stretch/>
        </p:blipFill>
        <p:spPr bwMode="auto">
          <a:xfrm>
            <a:off x="1901704" y="1115616"/>
            <a:ext cx="2862274" cy="7821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B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101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429000" y="7740352"/>
            <a:ext cx="396044" cy="7200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4992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84" y="98212"/>
            <a:ext cx="2359377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b="1" dirty="0"/>
              <a:t>Supplementary 3C.</a:t>
            </a:r>
            <a:endParaRPr lang="ko-KR" altLang="en-US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88740" y="818292"/>
            <a:ext cx="2359377" cy="46166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latinLnBrk="1"/>
            <a:r>
              <a:rPr lang="en-US" sz="2400" b="1" dirty="0"/>
              <a:t>ST685</a:t>
            </a:r>
            <a:endParaRPr lang="ko-KR" altLang="en-US" sz="2400" i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4098" name="Picture 2" descr="R:\Jeong_lab\Hemmos Lab member folders\Hemmos-Shinyoung\AMR_ESBL_commercial\Parsnp_coregenome\phylogeny of esbls in commercial farm\ST685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800" y="2267744"/>
            <a:ext cx="3606800" cy="32369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2600908" y="3239852"/>
            <a:ext cx="828092" cy="21602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981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64</Words>
  <Application>Microsoft Macintosh PowerPoint</Application>
  <PresentationFormat>On-screen Show (4:3)</PresentationFormat>
  <Paragraphs>264</Paragraphs>
  <Slides>21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Arial Unicode M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ong,KwangCheol Casey</dc:creator>
  <cp:lastModifiedBy>Jeong,KwangCheol Casey</cp:lastModifiedBy>
  <cp:revision>1</cp:revision>
  <dcterms:created xsi:type="dcterms:W3CDTF">2019-11-01T14:28:58Z</dcterms:created>
  <dcterms:modified xsi:type="dcterms:W3CDTF">2019-11-01T14:30:25Z</dcterms:modified>
</cp:coreProperties>
</file>